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66" r:id="rId4"/>
    <p:sldId id="267" r:id="rId5"/>
    <p:sldId id="259" r:id="rId6"/>
    <p:sldId id="261" r:id="rId7"/>
    <p:sldId id="262" r:id="rId8"/>
    <p:sldId id="260" r:id="rId9"/>
  </p:sldIdLst>
  <p:sldSz cx="6858000" cy="9144000" type="screen4x3"/>
  <p:notesSz cx="7077075" cy="9363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 showGuides="1">
      <p:cViewPr>
        <p:scale>
          <a:sx n="80" d="100"/>
          <a:sy n="80" d="100"/>
        </p:scale>
        <p:origin x="-3960" y="-234"/>
      </p:cViewPr>
      <p:guideLst>
        <p:guide orient="horz" pos="2718"/>
        <p:guide pos="2160"/>
        <p:guide pos="432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42" d="100"/>
        <a:sy n="142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0ACF0-C585-42AD-A81F-A38D4E60EE6B}" type="datetimeFigureOut">
              <a:rPr lang="en-US" smtClean="0"/>
              <a:t>2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7A28B-3518-4B52-BBE5-A4FF65C094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11123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0ACF0-C585-42AD-A81F-A38D4E60EE6B}" type="datetimeFigureOut">
              <a:rPr lang="en-US" smtClean="0"/>
              <a:t>2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7A28B-3518-4B52-BBE5-A4FF65C094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6109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0ACF0-C585-42AD-A81F-A38D4E60EE6B}" type="datetimeFigureOut">
              <a:rPr lang="en-US" smtClean="0"/>
              <a:t>2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7A28B-3518-4B52-BBE5-A4FF65C094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5898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0ACF0-C585-42AD-A81F-A38D4E60EE6B}" type="datetimeFigureOut">
              <a:rPr lang="en-US" smtClean="0"/>
              <a:t>2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7A28B-3518-4B52-BBE5-A4FF65C094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9294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0ACF0-C585-42AD-A81F-A38D4E60EE6B}" type="datetimeFigureOut">
              <a:rPr lang="en-US" smtClean="0"/>
              <a:t>2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7A28B-3518-4B52-BBE5-A4FF65C094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2990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0ACF0-C585-42AD-A81F-A38D4E60EE6B}" type="datetimeFigureOut">
              <a:rPr lang="en-US" smtClean="0"/>
              <a:t>2/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7A28B-3518-4B52-BBE5-A4FF65C094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3904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0ACF0-C585-42AD-A81F-A38D4E60EE6B}" type="datetimeFigureOut">
              <a:rPr lang="en-US" smtClean="0"/>
              <a:t>2/1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7A28B-3518-4B52-BBE5-A4FF65C094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2181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0ACF0-C585-42AD-A81F-A38D4E60EE6B}" type="datetimeFigureOut">
              <a:rPr lang="en-US" smtClean="0"/>
              <a:t>2/1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7A28B-3518-4B52-BBE5-A4FF65C094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63588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0ACF0-C585-42AD-A81F-A38D4E60EE6B}" type="datetimeFigureOut">
              <a:rPr lang="en-US" smtClean="0"/>
              <a:t>2/1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7A28B-3518-4B52-BBE5-A4FF65C094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11611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0ACF0-C585-42AD-A81F-A38D4E60EE6B}" type="datetimeFigureOut">
              <a:rPr lang="en-US" smtClean="0"/>
              <a:t>2/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7A28B-3518-4B52-BBE5-A4FF65C094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22400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D0ACF0-C585-42AD-A81F-A38D4E60EE6B}" type="datetimeFigureOut">
              <a:rPr lang="en-US" smtClean="0"/>
              <a:t>2/1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07A28B-3518-4B52-BBE5-A4FF65C094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1705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D0ACF0-C585-42AD-A81F-A38D4E60EE6B}" type="datetimeFigureOut">
              <a:rPr lang="en-US" smtClean="0"/>
              <a:t>2/1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07A28B-3518-4B52-BBE5-A4FF65C094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74773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055286" y="6605239"/>
            <a:ext cx="8391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12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sz="1400" dirty="0"/>
              <a:t>Figure 1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2043" y="679407"/>
            <a:ext cx="5785658" cy="57856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409997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3044375" y="5029200"/>
            <a:ext cx="8242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dirty="0"/>
              <a:t>Figure 2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7991" y="1985990"/>
            <a:ext cx="4696968" cy="22981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58429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2918019" y="6172200"/>
            <a:ext cx="112950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dirty="0"/>
              <a:t>Figure 3 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355" y="980783"/>
            <a:ext cx="5129784" cy="42611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59476121"/>
      </p:ext>
    </p:extLst>
  </p:cSld>
  <p:clrMapOvr>
    <a:masterClrMapping/>
  </p:clrMapOvr>
  <p:timing>
    <p:tnLst>
      <p:par>
        <p:cTn id="1" dur="indefinite" restart="never" nodeType="tmRoot">
          <p:childTnLst>
            <p:par>
              <p:cTn id="2"/>
            </p:par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989929" y="7809286"/>
            <a:ext cx="7349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4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Straight Arrow Connector 20"/>
          <p:cNvCxnSpPr/>
          <p:nvPr/>
        </p:nvCxnSpPr>
        <p:spPr>
          <a:xfrm>
            <a:off x="2570551" y="6097292"/>
            <a:ext cx="214850" cy="165903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2837" y="524592"/>
            <a:ext cx="2929128" cy="68122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990931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927172" y="6684010"/>
            <a:ext cx="8242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dirty="0"/>
              <a:t>Figure </a:t>
            </a:r>
            <a:r>
              <a:rPr lang="en-US" dirty="0" smtClean="0"/>
              <a:t>5</a:t>
            </a:r>
            <a:endParaRPr lang="en-US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2836" y="2260824"/>
            <a:ext cx="5672328" cy="37673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17353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904916" y="6068199"/>
            <a:ext cx="8690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dirty="0"/>
              <a:t>Figure  </a:t>
            </a:r>
            <a:r>
              <a:rPr lang="en-US" dirty="0" smtClean="0"/>
              <a:t>6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7971" y="1841940"/>
            <a:ext cx="5860473" cy="34889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46212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927172" y="6096000"/>
            <a:ext cx="8242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dirty="0"/>
              <a:t>Figure </a:t>
            </a:r>
            <a:r>
              <a:rPr lang="en-US" dirty="0" smtClean="0"/>
              <a:t>7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872" y="1324970"/>
            <a:ext cx="6400800" cy="40477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949015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3016897" y="4985811"/>
            <a:ext cx="8242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ctr">
              <a:defRPr sz="14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/>
              <a:t>Figure </a:t>
            </a:r>
            <a:r>
              <a:rPr lang="en-US" smtClean="0"/>
              <a:t>8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6910" y="1601150"/>
            <a:ext cx="4036352" cy="28617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46373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136</TotalTime>
  <Words>16</Words>
  <Application>Microsoft Office PowerPoint</Application>
  <PresentationFormat>On-screen Show (4:3)</PresentationFormat>
  <Paragraphs>8</Paragraphs>
  <Slides>8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OSU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ldovan, Nicanor</dc:creator>
  <cp:lastModifiedBy>Moldovan, Nicanor</cp:lastModifiedBy>
  <cp:revision>113</cp:revision>
  <cp:lastPrinted>2014-08-29T16:50:38Z</cp:lastPrinted>
  <dcterms:created xsi:type="dcterms:W3CDTF">2014-07-18T22:16:44Z</dcterms:created>
  <dcterms:modified xsi:type="dcterms:W3CDTF">2015-02-02T00:31:29Z</dcterms:modified>
</cp:coreProperties>
</file>